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EFBC01-CE81-49E5-AFFF-D278BE34E9B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D99890E-7111-4A21-A9A2-194A1A32C6B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5E5845-609F-4EA3-ABFD-B9859180A8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49C5A1-481C-4B45-A37F-53BD3474D9A5}" type="datetimeFigureOut">
              <a:rPr lang="en-US" smtClean="0"/>
              <a:t>4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BB2553-03B0-4EB6-B09D-D0E44A594A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DEE942-B8E8-4830-A8ED-FF8D337681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BF9B9-55AC-4BFB-A29F-64591AE8A5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9449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4F2927-CEB7-4EF0-81FF-AB3F3FA6FC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61BBEF1-CB04-4B43-B9DC-3D9AC9DFDD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B10F8E-2CC6-4E3D-9DAE-D94D55F182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49C5A1-481C-4B45-A37F-53BD3474D9A5}" type="datetimeFigureOut">
              <a:rPr lang="en-US" smtClean="0"/>
              <a:t>4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5EA8DA-4B8E-4328-B2BE-C4EE3A1ADC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5BD21A-A4F0-4311-BFDF-80DE03F4CA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BF9B9-55AC-4BFB-A29F-64591AE8A5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3021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282861B-C870-4034-8A97-3DFCEA6003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81AE025-A896-4C30-9591-89EEAF49B2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B792C5-092A-453F-A235-0B33CAC539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49C5A1-481C-4B45-A37F-53BD3474D9A5}" type="datetimeFigureOut">
              <a:rPr lang="en-US" smtClean="0"/>
              <a:t>4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861B30-7333-48F7-AEFC-38276B23DB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DDFC6D-B016-45F4-A4E9-21E6EEB4C4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BF9B9-55AC-4BFB-A29F-64591AE8A5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7886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5095EE-0128-49E9-B5EC-C270150C9B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587F39-FB78-45D8-B021-AE71631EFE2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BB601C-1BC8-48A5-9CB0-9C35D8B9DA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49C5A1-481C-4B45-A37F-53BD3474D9A5}" type="datetimeFigureOut">
              <a:rPr lang="en-US" smtClean="0"/>
              <a:t>4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985473-8584-4FD6-B614-7FDB7FAB0C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82BB86-2633-4CBF-A0AD-8B46DECC90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BF9B9-55AC-4BFB-A29F-64591AE8A5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88056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EC2232-7A1E-4421-AC40-DA13DD1878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3570A5-6DE0-4AB3-8E1E-37C6C8CECF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E85C39-966B-4D80-9A40-818A166045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49C5A1-481C-4B45-A37F-53BD3474D9A5}" type="datetimeFigureOut">
              <a:rPr lang="en-US" smtClean="0"/>
              <a:t>4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6A02C2-3232-462E-A92D-0230C24E51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760871-083E-49F3-BCD2-3D7602BAAD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BF9B9-55AC-4BFB-A29F-64591AE8A5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1895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A54BC2-9C1F-4BAA-86CC-11A5601770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5FB1BA-4840-41E4-91A3-2844AB3D3FF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557F74-2126-433F-991D-4E1A1F0266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A6AAE4C-D1E2-4739-B4BD-2FA6900B09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49C5A1-481C-4B45-A37F-53BD3474D9A5}" type="datetimeFigureOut">
              <a:rPr lang="en-US" smtClean="0"/>
              <a:t>4/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51FBF64-E6B3-4979-8610-7841CC2419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CA3CEE8-B207-41FD-8B77-96CED84A5B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BF9B9-55AC-4BFB-A29F-64591AE8A5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39878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AAA3DB-C419-466B-8A25-BB6B8198C0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CD9CBE-E831-4EA8-B009-E9924F7110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E77EFC4-6852-4BFA-BF2F-7AF7634301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D6C4C2D-85A3-42BF-9789-7E6B1205887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E593EF8-E5D4-4D6A-9B43-629F0DFCDEC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8E55AF9-3A74-4DBC-A746-43641B3D50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49C5A1-481C-4B45-A37F-53BD3474D9A5}" type="datetimeFigureOut">
              <a:rPr lang="en-US" smtClean="0"/>
              <a:t>4/5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70514B8-7B9C-4A33-8309-FC17C16366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401B2D6-8816-4DD4-9DFA-3B17CEFC17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BF9B9-55AC-4BFB-A29F-64591AE8A5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728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8D017E-F848-4725-99AB-945F208919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E90120E-6F1A-490B-9084-B1402C048C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49C5A1-481C-4B45-A37F-53BD3474D9A5}" type="datetimeFigureOut">
              <a:rPr lang="en-US" smtClean="0"/>
              <a:t>4/5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F666F92-A642-40BF-B819-6161EA97ED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20CA368-8337-49B4-86F5-6E85C86E5B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BF9B9-55AC-4BFB-A29F-64591AE8A5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3988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214E8AD-EA1A-4B1B-8EC2-1C5F6B872A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49C5A1-481C-4B45-A37F-53BD3474D9A5}" type="datetimeFigureOut">
              <a:rPr lang="en-US" smtClean="0"/>
              <a:t>4/5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5A7FF61-88A2-4201-B9DD-0B7D91B7B9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F11BF5A-4580-4387-8713-3B4E013937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BF9B9-55AC-4BFB-A29F-64591AE8A5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20124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ECD933-A671-4C13-B4FB-D61D41B7F8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3E1EB87-64B1-4570-B6A7-364A68741F6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BA92806-3F62-4C77-AAA3-1555721BA9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B7B3725-2055-406C-AF6D-B0869E25CD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49C5A1-481C-4B45-A37F-53BD3474D9A5}" type="datetimeFigureOut">
              <a:rPr lang="en-US" smtClean="0"/>
              <a:t>4/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0A07784-BFCC-40B7-9D1C-30EB8DFDC7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730A85-3FD6-4193-817F-55D0C6D8B0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BF9B9-55AC-4BFB-A29F-64591AE8A5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14582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97825B-6A3D-4E7B-85D7-F4AB095C73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A0413E8-CB21-446C-9A03-5408E24B9D3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533816D-FB5C-4DC4-A573-CF6BEC9F0D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4DF9F13-C828-459C-8AFD-2092805A13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49C5A1-481C-4B45-A37F-53BD3474D9A5}" type="datetimeFigureOut">
              <a:rPr lang="en-US" smtClean="0"/>
              <a:t>4/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015D692-249A-4762-90DF-F85A0C2BAD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7BA7B1-52DC-47C1-A8F5-F3CBC2A113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7BF9B9-55AC-4BFB-A29F-64591AE8A5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8992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E1690C2-BFF7-4ED7-B556-8938A3AF15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C5AC25C-9E75-4AD6-8C74-8DC74CE89C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9DFADB-37DA-44D7-907D-04665D98BB8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49C5A1-481C-4B45-A37F-53BD3474D9A5}" type="datetimeFigureOut">
              <a:rPr lang="en-US" smtClean="0"/>
              <a:t>4/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0BAC0B-E5CA-4398-8AA5-E115C8FDB39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F7EE95-BBF5-42EB-AC8B-DEDF18972D4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7BF9B9-55AC-4BFB-A29F-64591AE8A5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96784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D2380C8-7399-4AD0-8870-3E5505FDDC8B}"/>
              </a:ext>
            </a:extLst>
          </p:cNvPr>
          <p:cNvSpPr txBox="1"/>
          <p:nvPr/>
        </p:nvSpPr>
        <p:spPr>
          <a:xfrm>
            <a:off x="1151137" y="5536497"/>
            <a:ext cx="1053187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mine and bis-succinimide groups at the center of PIBSI dispersant intercalated between sludge particles and polyisobutylene chains are extended into the base oil. 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087E815-E0E6-4E1B-BEFF-0E47DBFE68B0}"/>
              </a:ext>
            </a:extLst>
          </p:cNvPr>
          <p:cNvSpPr txBox="1"/>
          <p:nvPr/>
        </p:nvSpPr>
        <p:spPr>
          <a:xfrm>
            <a:off x="5714836" y="472750"/>
            <a:ext cx="775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ovie</a:t>
            </a:r>
          </a:p>
        </p:txBody>
      </p:sp>
      <p:pic>
        <p:nvPicPr>
          <p:cNvPr id="4" name="My Movie">
            <a:hlinkClick r:id="" action="ppaction://media"/>
            <a:extLst>
              <a:ext uri="{FF2B5EF4-FFF2-40B4-BE49-F238E27FC236}">
                <a16:creationId xmlns:a16="http://schemas.microsoft.com/office/drawing/2014/main" id="{1EDFAB1C-97AA-4800-8883-C3C6C2CF49AE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636190" y="1109709"/>
            <a:ext cx="6919620" cy="38894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3540726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0543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25</Words>
  <Application>Microsoft Office PowerPoint</Application>
  <PresentationFormat>Widescreen</PresentationFormat>
  <Paragraphs>2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rolyildirim</dc:creator>
  <cp:lastModifiedBy>erolyildirim</cp:lastModifiedBy>
  <cp:revision>7</cp:revision>
  <dcterms:created xsi:type="dcterms:W3CDTF">2025-03-11T11:01:01Z</dcterms:created>
  <dcterms:modified xsi:type="dcterms:W3CDTF">2025-04-05T19:31:07Z</dcterms:modified>
</cp:coreProperties>
</file>